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7537E2E-44C5-40A9-A216-C9D92CFDC03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12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6C3ECA8-9EC2-471E-8C7D-AD8C49FE98A3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BC9EEE-EADC-4FCE-9107-AF05CC7878C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7DFE7D-496B-4EAD-B090-4B4156607B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AA923D-CB86-4750-AF13-99E23CA6C18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9B3450-D007-4DF8-8C1E-6804571702E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894E2D-1B2D-42F5-98D3-058BBD2F4B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9FDA41-7824-4026-AA4C-54EBD334EE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50ADC3-9D14-403B-B313-0CD5D1C021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3222C8-4A9F-4FB2-B69F-3FDB62AEDA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27E71B-579F-4011-A458-05F10235E2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CB318A-D391-4724-8CF2-1030065CFA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4334DA-5364-4425-8B9A-94B4396AE7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E96061-DAF5-49D3-8557-D8FFE427EC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1073032-0EE2-4EE5-9E17-1774247D5FB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8.png"/><Relationship Id="rId10" Type="http://schemas.openxmlformats.org/officeDocument/2006/relationships/image" Target="../media/image8.png"/><Relationship Id="rId11" Type="http://schemas.openxmlformats.org/officeDocument/2006/relationships/slideLayout" Target="../slideLayouts/slideLayout1.xml"/><Relationship Id="rId1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94"/>
          <p:cNvSpPr/>
          <p:nvPr/>
        </p:nvSpPr>
        <p:spPr>
          <a:xfrm>
            <a:off x="279360" y="4975200"/>
            <a:ext cx="3151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b. BRCA1 (-) or mutation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9" name="雲 103"/>
          <p:cNvGrpSpPr/>
          <p:nvPr/>
        </p:nvGrpSpPr>
        <p:grpSpPr>
          <a:xfrm>
            <a:off x="1285920" y="6029280"/>
            <a:ext cx="1731960" cy="566640"/>
            <a:chOff x="1285920" y="6029280"/>
            <a:chExt cx="1731960" cy="566640"/>
          </a:xfrm>
        </p:grpSpPr>
        <p:pic>
          <p:nvPicPr>
            <p:cNvPr id="50" name="雲 103" descr=""/>
            <p:cNvPicPr/>
            <p:nvPr/>
          </p:nvPicPr>
          <p:blipFill>
            <a:blip r:embed="rId1"/>
            <a:stretch/>
          </p:blipFill>
          <p:spPr>
            <a:xfrm>
              <a:off x="1285920" y="6029280"/>
              <a:ext cx="1731960" cy="566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"/>
            <p:cNvSpPr/>
            <p:nvPr/>
          </p:nvSpPr>
          <p:spPr>
            <a:xfrm rot="153600">
              <a:off x="1530000" y="6107040"/>
              <a:ext cx="1122480" cy="36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2" name="フローチャート: 直接アクセス記憶 124"/>
          <p:cNvSpPr/>
          <p:nvPr/>
        </p:nvSpPr>
        <p:spPr>
          <a:xfrm rot="12162600">
            <a:off x="1687680" y="6972480"/>
            <a:ext cx="274320" cy="366480"/>
          </a:xfrm>
          <a:prstGeom prst="flowChartMagneticDrum">
            <a:avLst/>
          </a:prstGeom>
          <a:solidFill>
            <a:srgbClr val="ffff00"/>
          </a:solid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直線コネクタ 125"/>
          <p:cNvSpPr/>
          <p:nvPr/>
        </p:nvSpPr>
        <p:spPr>
          <a:xfrm>
            <a:off x="1698480" y="7104240"/>
            <a:ext cx="84240" cy="3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直線コネクタ 126"/>
          <p:cNvSpPr/>
          <p:nvPr/>
        </p:nvSpPr>
        <p:spPr>
          <a:xfrm flipH="1">
            <a:off x="1663200" y="6950160"/>
            <a:ext cx="150840" cy="338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フリーフォーム 105"/>
          <p:cNvSpPr/>
          <p:nvPr/>
        </p:nvSpPr>
        <p:spPr>
          <a:xfrm rot="397800">
            <a:off x="1923840" y="7256160"/>
            <a:ext cx="1109520" cy="142920"/>
          </a:xfrm>
          <a:custGeom>
            <a:avLst/>
            <a:gdLst/>
            <a:ahLst/>
            <a:rect l="l" t="t" r="r" b="b"/>
            <a:pathLst>
              <a:path w="1871816" h="272523">
                <a:moveTo>
                  <a:pt x="1" y="128809"/>
                </a:moveTo>
                <a:cubicBezTo>
                  <a:pt x="15796" y="171456"/>
                  <a:pt x="59840" y="187153"/>
                  <a:pt x="100239" y="210194"/>
                </a:cubicBezTo>
                <a:cubicBezTo>
                  <a:pt x="140638" y="233235"/>
                  <a:pt x="189665" y="260494"/>
                  <a:pt x="242398" y="267057"/>
                </a:cubicBezTo>
                <a:cubicBezTo>
                  <a:pt x="295131" y="273620"/>
                  <a:pt x="348100" y="280025"/>
                  <a:pt x="416637" y="249571"/>
                </a:cubicBezTo>
                <a:cubicBezTo>
                  <a:pt x="485174" y="219117"/>
                  <a:pt x="580041" y="128654"/>
                  <a:pt x="653619" y="84331"/>
                </a:cubicBezTo>
                <a:cubicBezTo>
                  <a:pt x="727197" y="40008"/>
                  <a:pt x="778081" y="3337"/>
                  <a:pt x="861261" y="6023"/>
                </a:cubicBezTo>
                <a:cubicBezTo>
                  <a:pt x="944441" y="8710"/>
                  <a:pt x="1074160" y="71867"/>
                  <a:pt x="1152701" y="100450"/>
                </a:cubicBezTo>
                <a:cubicBezTo>
                  <a:pt x="1231242" y="129033"/>
                  <a:pt x="1274099" y="162562"/>
                  <a:pt x="1332507" y="177524"/>
                </a:cubicBezTo>
                <a:cubicBezTo>
                  <a:pt x="1390915" y="192486"/>
                  <a:pt x="1445099" y="199549"/>
                  <a:pt x="1503150" y="190225"/>
                </a:cubicBezTo>
                <a:cubicBezTo>
                  <a:pt x="1561201" y="180901"/>
                  <a:pt x="1632640" y="144504"/>
                  <a:pt x="1680812" y="121581"/>
                </a:cubicBezTo>
                <a:cubicBezTo>
                  <a:pt x="1728984" y="98658"/>
                  <a:pt x="1761816" y="72670"/>
                  <a:pt x="1792183" y="52689"/>
                </a:cubicBezTo>
                <a:cubicBezTo>
                  <a:pt x="1822550" y="32708"/>
                  <a:pt x="1847219" y="6436"/>
                  <a:pt x="1863014" y="1697"/>
                </a:cubicBezTo>
                <a:cubicBezTo>
                  <a:pt x="1878809" y="-3042"/>
                  <a:pt x="1868529" y="3651"/>
                  <a:pt x="1868529" y="3651"/>
                </a:cubicBezTo>
              </a:path>
            </a:pathLst>
          </a:custGeom>
          <a:noFill/>
          <a:ln cap="rnd" w="31680">
            <a:solidFill>
              <a:srgbClr val="17375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6" name="フローチャート: 結合子 106"/>
          <p:cNvGrpSpPr/>
          <p:nvPr/>
        </p:nvGrpSpPr>
        <p:grpSpPr>
          <a:xfrm>
            <a:off x="1768320" y="6188040"/>
            <a:ext cx="766800" cy="352440"/>
            <a:chOff x="1768320" y="6188040"/>
            <a:chExt cx="766800" cy="352440"/>
          </a:xfrm>
        </p:grpSpPr>
        <p:pic>
          <p:nvPicPr>
            <p:cNvPr id="57" name="フローチャート: 結合子 106" descr=""/>
            <p:cNvPicPr/>
            <p:nvPr/>
          </p:nvPicPr>
          <p:blipFill>
            <a:blip r:embed="rId2"/>
            <a:stretch/>
          </p:blipFill>
          <p:spPr>
            <a:xfrm>
              <a:off x="1768320" y="6188040"/>
              <a:ext cx="766800" cy="352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"/>
            <p:cNvSpPr/>
            <p:nvPr/>
          </p:nvSpPr>
          <p:spPr>
            <a:xfrm>
              <a:off x="1886040" y="6246720"/>
              <a:ext cx="533160" cy="238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ZH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9" name="直線コネクタ 109"/>
          <p:cNvSpPr/>
          <p:nvPr/>
        </p:nvSpPr>
        <p:spPr>
          <a:xfrm flipH="1">
            <a:off x="1895400" y="6923160"/>
            <a:ext cx="68400" cy="63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テキスト ボックス 111"/>
          <p:cNvSpPr/>
          <p:nvPr/>
        </p:nvSpPr>
        <p:spPr>
          <a:xfrm>
            <a:off x="1388160" y="6141960"/>
            <a:ext cx="51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RC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フリーフォーム 112"/>
          <p:cNvSpPr/>
          <p:nvPr/>
        </p:nvSpPr>
        <p:spPr>
          <a:xfrm>
            <a:off x="1751040" y="6991200"/>
            <a:ext cx="204840" cy="354240"/>
          </a:xfrm>
          <a:custGeom>
            <a:avLst/>
            <a:gdLst/>
            <a:ahLst/>
            <a:rect l="l" t="t" r="r" b="b"/>
            <a:pathLst>
              <a:path w="362532" h="639858">
                <a:moveTo>
                  <a:pt x="296131" y="0"/>
                </a:moveTo>
                <a:cubicBezTo>
                  <a:pt x="317487" y="475"/>
                  <a:pt x="336338" y="2202"/>
                  <a:pt x="347385" y="17086"/>
                </a:cubicBezTo>
                <a:cubicBezTo>
                  <a:pt x="358432" y="31970"/>
                  <a:pt x="363383" y="59905"/>
                  <a:pt x="362414" y="89303"/>
                </a:cubicBezTo>
                <a:cubicBezTo>
                  <a:pt x="361445" y="118701"/>
                  <a:pt x="351714" y="155350"/>
                  <a:pt x="341572" y="193472"/>
                </a:cubicBezTo>
                <a:cubicBezTo>
                  <a:pt x="331430" y="231594"/>
                  <a:pt x="317928" y="275786"/>
                  <a:pt x="301562" y="318035"/>
                </a:cubicBezTo>
                <a:cubicBezTo>
                  <a:pt x="285196" y="360284"/>
                  <a:pt x="265236" y="406809"/>
                  <a:pt x="243377" y="446967"/>
                </a:cubicBezTo>
                <a:cubicBezTo>
                  <a:pt x="221518" y="487125"/>
                  <a:pt x="193858" y="528896"/>
                  <a:pt x="170409" y="558983"/>
                </a:cubicBezTo>
                <a:cubicBezTo>
                  <a:pt x="146960" y="589070"/>
                  <a:pt x="125388" y="614341"/>
                  <a:pt x="102681" y="627487"/>
                </a:cubicBezTo>
                <a:cubicBezTo>
                  <a:pt x="79974" y="640633"/>
                  <a:pt x="51283" y="641824"/>
                  <a:pt x="34169" y="637857"/>
                </a:cubicBezTo>
                <a:cubicBezTo>
                  <a:pt x="17055" y="633890"/>
                  <a:pt x="7119" y="610805"/>
                  <a:pt x="0" y="603686"/>
                </a:cubicBezTo>
              </a:path>
            </a:pathLst>
          </a:custGeom>
          <a:noFill/>
          <a:ln cap="rnd" w="31680">
            <a:solidFill>
              <a:srgbClr val="17375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2" name="直線矢印コネクタ 113"/>
          <p:cNvCxnSpPr/>
          <p:nvPr/>
        </p:nvCxnSpPr>
        <p:spPr>
          <a:xfrm>
            <a:off x="2152440" y="6538680"/>
            <a:ext cx="1080" cy="28332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lg"/>
          </a:ln>
        </p:spPr>
      </p:cxnSp>
      <p:sp>
        <p:nvSpPr>
          <p:cNvPr id="63" name="テキスト ボックス 123"/>
          <p:cNvSpPr/>
          <p:nvPr/>
        </p:nvSpPr>
        <p:spPr>
          <a:xfrm>
            <a:off x="2970360" y="7026120"/>
            <a:ext cx="59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e46c0a"/>
                </a:solidFill>
                <a:latin typeface="Arial"/>
                <a:ea typeface="Arial"/>
              </a:rPr>
              <a:t>OFF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直線コネクタ 119"/>
          <p:cNvSpPr/>
          <p:nvPr/>
        </p:nvSpPr>
        <p:spPr>
          <a:xfrm>
            <a:off x="2152800" y="5676840"/>
            <a:ext cx="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フリーフォーム 117"/>
          <p:cNvSpPr/>
          <p:nvPr/>
        </p:nvSpPr>
        <p:spPr>
          <a:xfrm>
            <a:off x="1244520" y="6964200"/>
            <a:ext cx="631800" cy="422280"/>
          </a:xfrm>
          <a:custGeom>
            <a:avLst/>
            <a:gdLst/>
            <a:ahLst/>
            <a:rect l="l" t="t" r="r" b="b"/>
            <a:pathLst>
              <a:path w="1113496" h="765815">
                <a:moveTo>
                  <a:pt x="1063707" y="0"/>
                </a:moveTo>
                <a:cubicBezTo>
                  <a:pt x="1067470" y="4619"/>
                  <a:pt x="1085703" y="-4305"/>
                  <a:pt x="1093799" y="5168"/>
                </a:cubicBezTo>
                <a:cubicBezTo>
                  <a:pt x="1101895" y="14641"/>
                  <a:pt x="1109781" y="30067"/>
                  <a:pt x="1112282" y="56837"/>
                </a:cubicBezTo>
                <a:cubicBezTo>
                  <a:pt x="1115371" y="87168"/>
                  <a:pt x="1112866" y="135792"/>
                  <a:pt x="1101292" y="188334"/>
                </a:cubicBezTo>
                <a:cubicBezTo>
                  <a:pt x="1089718" y="240876"/>
                  <a:pt x="1064976" y="317490"/>
                  <a:pt x="1042837" y="372087"/>
                </a:cubicBezTo>
                <a:cubicBezTo>
                  <a:pt x="1020698" y="426684"/>
                  <a:pt x="992380" y="475602"/>
                  <a:pt x="968459" y="515919"/>
                </a:cubicBezTo>
                <a:cubicBezTo>
                  <a:pt x="944538" y="556236"/>
                  <a:pt x="932103" y="582451"/>
                  <a:pt x="899311" y="613987"/>
                </a:cubicBezTo>
                <a:cubicBezTo>
                  <a:pt x="866519" y="645523"/>
                  <a:pt x="816321" y="679842"/>
                  <a:pt x="771706" y="705133"/>
                </a:cubicBezTo>
                <a:cubicBezTo>
                  <a:pt x="727092" y="730425"/>
                  <a:pt x="676321" y="763848"/>
                  <a:pt x="631624" y="765736"/>
                </a:cubicBezTo>
                <a:cubicBezTo>
                  <a:pt x="586927" y="767624"/>
                  <a:pt x="541564" y="735334"/>
                  <a:pt x="503523" y="716464"/>
                </a:cubicBezTo>
                <a:cubicBezTo>
                  <a:pt x="465482" y="697594"/>
                  <a:pt x="446789" y="675670"/>
                  <a:pt x="403378" y="652514"/>
                </a:cubicBezTo>
                <a:cubicBezTo>
                  <a:pt x="359967" y="629358"/>
                  <a:pt x="292058" y="576861"/>
                  <a:pt x="243058" y="577529"/>
                </a:cubicBezTo>
                <a:cubicBezTo>
                  <a:pt x="194058" y="578197"/>
                  <a:pt x="149886" y="628165"/>
                  <a:pt x="109376" y="656521"/>
                </a:cubicBezTo>
                <a:cubicBezTo>
                  <a:pt x="68866" y="684877"/>
                  <a:pt x="13166" y="746654"/>
                  <a:pt x="0" y="747667"/>
                </a:cubicBezTo>
              </a:path>
            </a:pathLst>
          </a:custGeom>
          <a:noFill/>
          <a:ln cap="rnd" w="31680">
            <a:solidFill>
              <a:srgbClr val="17375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17"/>
          <p:cNvSpPr/>
          <p:nvPr/>
        </p:nvSpPr>
        <p:spPr>
          <a:xfrm>
            <a:off x="4111560" y="6556320"/>
            <a:ext cx="214632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OXA1 expression silenced;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Transition from Luminal to Basa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45"/>
          <p:cNvSpPr/>
          <p:nvPr/>
        </p:nvSpPr>
        <p:spPr>
          <a:xfrm>
            <a:off x="2120400" y="7294680"/>
            <a:ext cx="60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pG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8" name="Group 3"/>
          <p:cNvGrpSpPr/>
          <p:nvPr/>
        </p:nvGrpSpPr>
        <p:grpSpPr>
          <a:xfrm>
            <a:off x="2217600" y="6927840"/>
            <a:ext cx="392400" cy="351000"/>
            <a:chOff x="2217600" y="6927840"/>
            <a:chExt cx="392400" cy="351000"/>
          </a:xfrm>
        </p:grpSpPr>
        <p:sp>
          <p:nvSpPr>
            <p:cNvPr id="69" name="Straight Connector 51"/>
            <p:cNvSpPr/>
            <p:nvPr/>
          </p:nvSpPr>
          <p:spPr>
            <a:xfrm flipV="1">
              <a:off x="2360520" y="7162920"/>
              <a:ext cx="0" cy="11592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Box 253"/>
            <p:cNvSpPr/>
            <p:nvPr/>
          </p:nvSpPr>
          <p:spPr>
            <a:xfrm>
              <a:off x="2217600" y="6927840"/>
              <a:ext cx="392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953735"/>
                  </a:solidFill>
                  <a:latin typeface="Arial"/>
                  <a:ea typeface="Arial"/>
                </a:rPr>
                <a:t>m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1" name="TextBox 75"/>
          <p:cNvSpPr/>
          <p:nvPr/>
        </p:nvSpPr>
        <p:spPr>
          <a:xfrm>
            <a:off x="2533320" y="3905280"/>
            <a:ext cx="60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pG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フローチャート: 結合子 106"/>
          <p:cNvSpPr/>
          <p:nvPr/>
        </p:nvSpPr>
        <p:spPr>
          <a:xfrm>
            <a:off x="1677960" y="5538960"/>
            <a:ext cx="938160" cy="338040"/>
          </a:xfrm>
          <a:prstGeom prst="flowChartConnector">
            <a:avLst/>
          </a:prstGeom>
          <a:gradFill rotWithShape="0">
            <a:gsLst>
              <a:gs pos="0">
                <a:srgbClr val="ffe5e5"/>
              </a:gs>
              <a:gs pos="100000">
                <a:srgbClr val="ffa2a1"/>
              </a:gs>
            </a:gsLst>
            <a:lin ang="5400000"/>
          </a:gradFill>
          <a:ln w="9360">
            <a:solidFill>
              <a:srgbClr val="be4b48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BRCA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256"/>
          <p:cNvSpPr/>
          <p:nvPr/>
        </p:nvSpPr>
        <p:spPr>
          <a:xfrm>
            <a:off x="1925640" y="5369040"/>
            <a:ext cx="3808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3600" spc="-1" strike="noStrike">
                <a:solidFill>
                  <a:srgbClr val="ff0000"/>
                </a:solidFill>
                <a:latin typeface="Arial"/>
                <a:ea typeface="Arial"/>
              </a:rPr>
              <a:t>X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261"/>
          <p:cNvSpPr/>
          <p:nvPr/>
        </p:nvSpPr>
        <p:spPr>
          <a:xfrm>
            <a:off x="3000240" y="1833480"/>
            <a:ext cx="21146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(1) Inhibit EZH2 and thus histone and gene promoter methylation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262"/>
          <p:cNvSpPr/>
          <p:nvPr/>
        </p:nvSpPr>
        <p:spPr>
          <a:xfrm>
            <a:off x="2247840" y="4194000"/>
            <a:ext cx="16257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(2) Activates of FOXA1 transcrip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148"/>
          <p:cNvSpPr/>
          <p:nvPr/>
        </p:nvSpPr>
        <p:spPr>
          <a:xfrm>
            <a:off x="257040" y="1317600"/>
            <a:ext cx="17323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a. BRCA1 (+)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7" name="雲 103"/>
          <p:cNvGrpSpPr/>
          <p:nvPr/>
        </p:nvGrpSpPr>
        <p:grpSpPr>
          <a:xfrm>
            <a:off x="1341360" y="2352600"/>
            <a:ext cx="2067120" cy="658800"/>
            <a:chOff x="1341360" y="2352600"/>
            <a:chExt cx="2067120" cy="658800"/>
          </a:xfrm>
        </p:grpSpPr>
        <p:pic>
          <p:nvPicPr>
            <p:cNvPr id="78" name="雲 103" descr=""/>
            <p:cNvPicPr/>
            <p:nvPr/>
          </p:nvPicPr>
          <p:blipFill>
            <a:blip r:embed="rId3"/>
            <a:stretch/>
          </p:blipFill>
          <p:spPr>
            <a:xfrm>
              <a:off x="1341360" y="2352600"/>
              <a:ext cx="2067120" cy="65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9" name=""/>
            <p:cNvSpPr/>
            <p:nvPr/>
          </p:nvSpPr>
          <p:spPr>
            <a:xfrm rot="153600">
              <a:off x="1635120" y="2446200"/>
              <a:ext cx="1336680" cy="420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0" name="フローチャート: 直接アクセス記憶 124"/>
          <p:cNvSpPr/>
          <p:nvPr/>
        </p:nvSpPr>
        <p:spPr>
          <a:xfrm rot="12162600">
            <a:off x="1822320" y="3638520"/>
            <a:ext cx="325440" cy="425520"/>
          </a:xfrm>
          <a:prstGeom prst="flowChartMagneticDrum">
            <a:avLst/>
          </a:prstGeom>
          <a:solidFill>
            <a:srgbClr val="ffff00"/>
          </a:solid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直線コネクタ 125"/>
          <p:cNvSpPr/>
          <p:nvPr/>
        </p:nvSpPr>
        <p:spPr>
          <a:xfrm>
            <a:off x="1835280" y="3790800"/>
            <a:ext cx="9972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直線コネクタ 126"/>
          <p:cNvSpPr/>
          <p:nvPr/>
        </p:nvSpPr>
        <p:spPr>
          <a:xfrm flipH="1">
            <a:off x="1792440" y="3611520"/>
            <a:ext cx="180720" cy="393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フリーフォーム 105"/>
          <p:cNvSpPr/>
          <p:nvPr/>
        </p:nvSpPr>
        <p:spPr>
          <a:xfrm rot="397800">
            <a:off x="2111040" y="3849840"/>
            <a:ext cx="1558800" cy="298440"/>
          </a:xfrm>
          <a:custGeom>
            <a:avLst/>
            <a:gdLst/>
            <a:ahLst/>
            <a:rect l="l" t="t" r="r" b="b"/>
            <a:pathLst>
              <a:path w="1871816" h="272523">
                <a:moveTo>
                  <a:pt x="1" y="128809"/>
                </a:moveTo>
                <a:cubicBezTo>
                  <a:pt x="15796" y="171456"/>
                  <a:pt x="59840" y="187153"/>
                  <a:pt x="100239" y="210194"/>
                </a:cubicBezTo>
                <a:cubicBezTo>
                  <a:pt x="140638" y="233235"/>
                  <a:pt x="189665" y="260494"/>
                  <a:pt x="242398" y="267057"/>
                </a:cubicBezTo>
                <a:cubicBezTo>
                  <a:pt x="295131" y="273620"/>
                  <a:pt x="348100" y="280025"/>
                  <a:pt x="416637" y="249571"/>
                </a:cubicBezTo>
                <a:cubicBezTo>
                  <a:pt x="485174" y="219117"/>
                  <a:pt x="580041" y="128654"/>
                  <a:pt x="653619" y="84331"/>
                </a:cubicBezTo>
                <a:cubicBezTo>
                  <a:pt x="727197" y="40008"/>
                  <a:pt x="778081" y="3337"/>
                  <a:pt x="861261" y="6023"/>
                </a:cubicBezTo>
                <a:cubicBezTo>
                  <a:pt x="944441" y="8710"/>
                  <a:pt x="1074160" y="71867"/>
                  <a:pt x="1152701" y="100450"/>
                </a:cubicBezTo>
                <a:cubicBezTo>
                  <a:pt x="1231242" y="129033"/>
                  <a:pt x="1274099" y="162562"/>
                  <a:pt x="1332507" y="177524"/>
                </a:cubicBezTo>
                <a:cubicBezTo>
                  <a:pt x="1390915" y="192486"/>
                  <a:pt x="1445099" y="199549"/>
                  <a:pt x="1503150" y="190225"/>
                </a:cubicBezTo>
                <a:cubicBezTo>
                  <a:pt x="1561201" y="180901"/>
                  <a:pt x="1632640" y="144504"/>
                  <a:pt x="1680812" y="121581"/>
                </a:cubicBezTo>
                <a:cubicBezTo>
                  <a:pt x="1728984" y="98658"/>
                  <a:pt x="1761816" y="72670"/>
                  <a:pt x="1792183" y="52689"/>
                </a:cubicBezTo>
                <a:cubicBezTo>
                  <a:pt x="1822550" y="32708"/>
                  <a:pt x="1847219" y="6436"/>
                  <a:pt x="1863014" y="1697"/>
                </a:cubicBezTo>
                <a:cubicBezTo>
                  <a:pt x="1878809" y="-3042"/>
                  <a:pt x="1868529" y="3651"/>
                  <a:pt x="1868529" y="3651"/>
                </a:cubicBezTo>
              </a:path>
            </a:pathLst>
          </a:custGeom>
          <a:noFill/>
          <a:ln cap="rnd" w="31680">
            <a:solidFill>
              <a:srgbClr val="17375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4" name="フローチャート: 結合子 106"/>
          <p:cNvGrpSpPr/>
          <p:nvPr/>
        </p:nvGrpSpPr>
        <p:grpSpPr>
          <a:xfrm>
            <a:off x="1920960" y="2541600"/>
            <a:ext cx="914400" cy="409680"/>
            <a:chOff x="1920960" y="2541600"/>
            <a:chExt cx="914400" cy="409680"/>
          </a:xfrm>
        </p:grpSpPr>
        <p:pic>
          <p:nvPicPr>
            <p:cNvPr id="85" name="フローチャート: 結合子 106" descr=""/>
            <p:cNvPicPr/>
            <p:nvPr/>
          </p:nvPicPr>
          <p:blipFill>
            <a:blip r:embed="rId4"/>
            <a:stretch/>
          </p:blipFill>
          <p:spPr>
            <a:xfrm>
              <a:off x="1920960" y="2541600"/>
              <a:ext cx="914400" cy="409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6" name=""/>
            <p:cNvSpPr/>
            <p:nvPr/>
          </p:nvSpPr>
          <p:spPr>
            <a:xfrm>
              <a:off x="2057400" y="2608200"/>
              <a:ext cx="636480" cy="277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ZH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7" name="直線コネクタ 109"/>
          <p:cNvSpPr/>
          <p:nvPr/>
        </p:nvSpPr>
        <p:spPr>
          <a:xfrm flipH="1">
            <a:off x="2069640" y="3564000"/>
            <a:ext cx="8100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テキスト ボックス 111"/>
          <p:cNvSpPr/>
          <p:nvPr/>
        </p:nvSpPr>
        <p:spPr>
          <a:xfrm>
            <a:off x="1463760" y="2486160"/>
            <a:ext cx="51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RC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フリーフォーム 112"/>
          <p:cNvSpPr/>
          <p:nvPr/>
        </p:nvSpPr>
        <p:spPr>
          <a:xfrm>
            <a:off x="1897200" y="3660840"/>
            <a:ext cx="245880" cy="411120"/>
          </a:xfrm>
          <a:custGeom>
            <a:avLst/>
            <a:gdLst/>
            <a:ahLst/>
            <a:rect l="l" t="t" r="r" b="b"/>
            <a:pathLst>
              <a:path w="362532" h="639858">
                <a:moveTo>
                  <a:pt x="296131" y="0"/>
                </a:moveTo>
                <a:cubicBezTo>
                  <a:pt x="317487" y="475"/>
                  <a:pt x="336338" y="2202"/>
                  <a:pt x="347385" y="17086"/>
                </a:cubicBezTo>
                <a:cubicBezTo>
                  <a:pt x="358432" y="31970"/>
                  <a:pt x="363383" y="59905"/>
                  <a:pt x="362414" y="89303"/>
                </a:cubicBezTo>
                <a:cubicBezTo>
                  <a:pt x="361445" y="118701"/>
                  <a:pt x="351714" y="155350"/>
                  <a:pt x="341572" y="193472"/>
                </a:cubicBezTo>
                <a:cubicBezTo>
                  <a:pt x="331430" y="231594"/>
                  <a:pt x="317928" y="275786"/>
                  <a:pt x="301562" y="318035"/>
                </a:cubicBezTo>
                <a:cubicBezTo>
                  <a:pt x="285196" y="360284"/>
                  <a:pt x="265236" y="406809"/>
                  <a:pt x="243377" y="446967"/>
                </a:cubicBezTo>
                <a:cubicBezTo>
                  <a:pt x="221518" y="487125"/>
                  <a:pt x="193858" y="528896"/>
                  <a:pt x="170409" y="558983"/>
                </a:cubicBezTo>
                <a:cubicBezTo>
                  <a:pt x="146960" y="589070"/>
                  <a:pt x="125388" y="614341"/>
                  <a:pt x="102681" y="627487"/>
                </a:cubicBezTo>
                <a:cubicBezTo>
                  <a:pt x="79974" y="640633"/>
                  <a:pt x="51283" y="641824"/>
                  <a:pt x="34169" y="637857"/>
                </a:cubicBezTo>
                <a:cubicBezTo>
                  <a:pt x="17055" y="633890"/>
                  <a:pt x="7119" y="610805"/>
                  <a:pt x="0" y="603686"/>
                </a:cubicBezTo>
              </a:path>
            </a:pathLst>
          </a:custGeom>
          <a:noFill/>
          <a:ln cap="rnd" w="31680">
            <a:solidFill>
              <a:srgbClr val="17375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0" name="テキスト ボックス 123" descr=""/>
          <p:cNvPicPr/>
          <p:nvPr/>
        </p:nvPicPr>
        <p:blipFill>
          <a:blip r:embed="rId5"/>
          <a:stretch/>
        </p:blipFill>
        <p:spPr>
          <a:xfrm>
            <a:off x="3402000" y="3724200"/>
            <a:ext cx="431640" cy="257400"/>
          </a:xfrm>
          <a:prstGeom prst="rect">
            <a:avLst/>
          </a:prstGeom>
          <a:ln w="0">
            <a:noFill/>
          </a:ln>
        </p:spPr>
      </p:pic>
      <p:sp>
        <p:nvSpPr>
          <p:cNvPr id="91" name="直線コネクタ 119"/>
          <p:cNvSpPr/>
          <p:nvPr/>
        </p:nvSpPr>
        <p:spPr>
          <a:xfrm>
            <a:off x="2376360" y="1944720"/>
            <a:ext cx="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フリーフォーム 117"/>
          <p:cNvSpPr/>
          <p:nvPr/>
        </p:nvSpPr>
        <p:spPr>
          <a:xfrm>
            <a:off x="1293840" y="3627360"/>
            <a:ext cx="752400" cy="492120"/>
          </a:xfrm>
          <a:custGeom>
            <a:avLst/>
            <a:gdLst/>
            <a:ahLst/>
            <a:rect l="l" t="t" r="r" b="b"/>
            <a:pathLst>
              <a:path w="1113496" h="765815">
                <a:moveTo>
                  <a:pt x="1063707" y="0"/>
                </a:moveTo>
                <a:cubicBezTo>
                  <a:pt x="1067470" y="4619"/>
                  <a:pt x="1085703" y="-4305"/>
                  <a:pt x="1093799" y="5168"/>
                </a:cubicBezTo>
                <a:cubicBezTo>
                  <a:pt x="1101895" y="14641"/>
                  <a:pt x="1109781" y="30067"/>
                  <a:pt x="1112282" y="56837"/>
                </a:cubicBezTo>
                <a:cubicBezTo>
                  <a:pt x="1115371" y="87168"/>
                  <a:pt x="1112866" y="135792"/>
                  <a:pt x="1101292" y="188334"/>
                </a:cubicBezTo>
                <a:cubicBezTo>
                  <a:pt x="1089718" y="240876"/>
                  <a:pt x="1064976" y="317490"/>
                  <a:pt x="1042837" y="372087"/>
                </a:cubicBezTo>
                <a:cubicBezTo>
                  <a:pt x="1020698" y="426684"/>
                  <a:pt x="992380" y="475602"/>
                  <a:pt x="968459" y="515919"/>
                </a:cubicBezTo>
                <a:cubicBezTo>
                  <a:pt x="944538" y="556236"/>
                  <a:pt x="932103" y="582451"/>
                  <a:pt x="899311" y="613987"/>
                </a:cubicBezTo>
                <a:cubicBezTo>
                  <a:pt x="866519" y="645523"/>
                  <a:pt x="816321" y="679842"/>
                  <a:pt x="771706" y="705133"/>
                </a:cubicBezTo>
                <a:cubicBezTo>
                  <a:pt x="727092" y="730425"/>
                  <a:pt x="676321" y="763848"/>
                  <a:pt x="631624" y="765736"/>
                </a:cubicBezTo>
                <a:cubicBezTo>
                  <a:pt x="586927" y="767624"/>
                  <a:pt x="541564" y="735334"/>
                  <a:pt x="503523" y="716464"/>
                </a:cubicBezTo>
                <a:cubicBezTo>
                  <a:pt x="465482" y="697594"/>
                  <a:pt x="446789" y="675670"/>
                  <a:pt x="403378" y="652514"/>
                </a:cubicBezTo>
                <a:cubicBezTo>
                  <a:pt x="359967" y="629358"/>
                  <a:pt x="292058" y="576861"/>
                  <a:pt x="243058" y="577529"/>
                </a:cubicBezTo>
                <a:cubicBezTo>
                  <a:pt x="194058" y="578197"/>
                  <a:pt x="149886" y="628165"/>
                  <a:pt x="109376" y="656521"/>
                </a:cubicBezTo>
                <a:cubicBezTo>
                  <a:pt x="68866" y="684877"/>
                  <a:pt x="13166" y="746654"/>
                  <a:pt x="0" y="747667"/>
                </a:cubicBezTo>
              </a:path>
            </a:pathLst>
          </a:custGeom>
          <a:noFill/>
          <a:ln cap="rnd" w="31680">
            <a:solidFill>
              <a:srgbClr val="17375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Straight Connector 24"/>
          <p:cNvSpPr/>
          <p:nvPr/>
        </p:nvSpPr>
        <p:spPr>
          <a:xfrm>
            <a:off x="2416320" y="2152800"/>
            <a:ext cx="0" cy="2952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Straight Connector 222"/>
          <p:cNvSpPr/>
          <p:nvPr/>
        </p:nvSpPr>
        <p:spPr>
          <a:xfrm>
            <a:off x="2286000" y="2448000"/>
            <a:ext cx="26028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5" name="フローチャート: 結合子 107"/>
          <p:cNvGrpSpPr/>
          <p:nvPr/>
        </p:nvGrpSpPr>
        <p:grpSpPr>
          <a:xfrm>
            <a:off x="2852640" y="2998800"/>
            <a:ext cx="976320" cy="457200"/>
            <a:chOff x="2852640" y="2998800"/>
            <a:chExt cx="976320" cy="457200"/>
          </a:xfrm>
        </p:grpSpPr>
        <p:pic>
          <p:nvPicPr>
            <p:cNvPr id="96" name="フローチャート: 結合子 107" descr=""/>
            <p:cNvPicPr/>
            <p:nvPr/>
          </p:nvPicPr>
          <p:blipFill>
            <a:blip r:embed="rId6"/>
            <a:stretch/>
          </p:blipFill>
          <p:spPr>
            <a:xfrm>
              <a:off x="2852640" y="2998800"/>
              <a:ext cx="976320" cy="457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7" name=""/>
            <p:cNvSpPr/>
            <p:nvPr/>
          </p:nvSpPr>
          <p:spPr>
            <a:xfrm rot="1149600">
              <a:off x="2984040" y="3119040"/>
              <a:ext cx="712800" cy="22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NMT3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8" name="フローチャート: 結合子 106"/>
          <p:cNvSpPr/>
          <p:nvPr/>
        </p:nvSpPr>
        <p:spPr>
          <a:xfrm>
            <a:off x="1855800" y="1747800"/>
            <a:ext cx="1119240" cy="393840"/>
          </a:xfrm>
          <a:prstGeom prst="flowChartConnector">
            <a:avLst/>
          </a:prstGeom>
          <a:gradFill rotWithShape="0">
            <a:gsLst>
              <a:gs pos="0">
                <a:srgbClr val="ffe5e5"/>
              </a:gs>
              <a:gs pos="100000">
                <a:srgbClr val="ffa2a1"/>
              </a:gs>
            </a:gsLst>
            <a:lin ang="5400000"/>
          </a:gradFill>
          <a:ln w="9360">
            <a:solidFill>
              <a:srgbClr val="be4b48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BRCA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Box 263"/>
          <p:cNvSpPr/>
          <p:nvPr/>
        </p:nvSpPr>
        <p:spPr>
          <a:xfrm>
            <a:off x="4684680" y="2984400"/>
            <a:ext cx="21463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OXA1 expression retained;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uminal phenotyp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Right Arrow 264"/>
          <p:cNvSpPr/>
          <p:nvPr/>
        </p:nvSpPr>
        <p:spPr>
          <a:xfrm>
            <a:off x="4218120" y="3219480"/>
            <a:ext cx="531720" cy="230040"/>
          </a:xfrm>
          <a:prstGeom prst="rightArrow">
            <a:avLst>
              <a:gd name="adj1" fmla="val 50000"/>
              <a:gd name="adj2" fmla="val 50027"/>
            </a:avLst>
          </a:prstGeom>
          <a:solidFill>
            <a:srgbClr val="ffffff"/>
          </a:solidFill>
          <a:ln w="25560">
            <a:solidFill>
              <a:srgbClr val="4bacc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2"/>
          <p:cNvSpPr/>
          <p:nvPr/>
        </p:nvSpPr>
        <p:spPr>
          <a:xfrm>
            <a:off x="2065680" y="3408480"/>
            <a:ext cx="56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H3K2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71"/>
          <p:cNvSpPr/>
          <p:nvPr/>
        </p:nvSpPr>
        <p:spPr>
          <a:xfrm>
            <a:off x="1874880" y="6735600"/>
            <a:ext cx="782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H3K27m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Straight Connector 77"/>
          <p:cNvSpPr/>
          <p:nvPr/>
        </p:nvSpPr>
        <p:spPr>
          <a:xfrm flipV="1">
            <a:off x="2131920" y="7230960"/>
            <a:ext cx="0" cy="1159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TextBox 78"/>
          <p:cNvSpPr/>
          <p:nvPr/>
        </p:nvSpPr>
        <p:spPr>
          <a:xfrm>
            <a:off x="1989000" y="699624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953735"/>
                </a:solidFill>
                <a:latin typeface="Arial"/>
                <a:ea typeface="Arial"/>
              </a:rPr>
              <a:t>m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5" name="フローチャート: 結合子 107"/>
          <p:cNvGrpSpPr/>
          <p:nvPr/>
        </p:nvGrpSpPr>
        <p:grpSpPr>
          <a:xfrm>
            <a:off x="2341440" y="6345360"/>
            <a:ext cx="974880" cy="463320"/>
            <a:chOff x="2341440" y="6345360"/>
            <a:chExt cx="974880" cy="463320"/>
          </a:xfrm>
        </p:grpSpPr>
        <p:pic>
          <p:nvPicPr>
            <p:cNvPr id="106" name="フローチャート: 結合子 107" descr=""/>
            <p:cNvPicPr/>
            <p:nvPr/>
          </p:nvPicPr>
          <p:blipFill>
            <a:blip r:embed="rId7"/>
            <a:stretch/>
          </p:blipFill>
          <p:spPr>
            <a:xfrm>
              <a:off x="2341440" y="6345360"/>
              <a:ext cx="974880" cy="463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7" name=""/>
            <p:cNvSpPr/>
            <p:nvPr/>
          </p:nvSpPr>
          <p:spPr>
            <a:xfrm rot="1149600">
              <a:off x="2472840" y="6467040"/>
              <a:ext cx="712800" cy="222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NMT3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cxnSp>
        <p:nvCxnSpPr>
          <p:cNvPr id="108" name="直線矢印コネクタ 113"/>
          <p:cNvCxnSpPr/>
          <p:nvPr/>
        </p:nvCxnSpPr>
        <p:spPr>
          <a:xfrm flipH="1">
            <a:off x="2559960" y="6794280"/>
            <a:ext cx="283320" cy="261000"/>
          </a:xfrm>
          <a:prstGeom prst="straightConnector1">
            <a:avLst/>
          </a:prstGeom>
          <a:ln w="12600">
            <a:solidFill>
              <a:srgbClr val="953735"/>
            </a:solidFill>
            <a:prstDash val="dash"/>
            <a:miter/>
            <a:tailEnd len="med" type="triangle" w="med"/>
          </a:ln>
        </p:spPr>
      </p:cxnSp>
      <p:grpSp>
        <p:nvGrpSpPr>
          <p:cNvPr id="109" name="Group 13"/>
          <p:cNvGrpSpPr/>
          <p:nvPr/>
        </p:nvGrpSpPr>
        <p:grpSpPr>
          <a:xfrm>
            <a:off x="2728800" y="7066080"/>
            <a:ext cx="289080" cy="285480"/>
            <a:chOff x="2728800" y="7066080"/>
            <a:chExt cx="289080" cy="285480"/>
          </a:xfrm>
        </p:grpSpPr>
        <p:sp>
          <p:nvSpPr>
            <p:cNvPr id="110" name="Straight Connector 84"/>
            <p:cNvSpPr/>
            <p:nvPr/>
          </p:nvSpPr>
          <p:spPr>
            <a:xfrm flipV="1">
              <a:off x="2738160" y="7162920"/>
              <a:ext cx="0" cy="1886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Straight Connector 87"/>
            <p:cNvSpPr/>
            <p:nvPr/>
          </p:nvSpPr>
          <p:spPr>
            <a:xfrm>
              <a:off x="2728800" y="7161120"/>
              <a:ext cx="27828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Straight Connector 90"/>
            <p:cNvSpPr/>
            <p:nvPr/>
          </p:nvSpPr>
          <p:spPr>
            <a:xfrm flipV="1">
              <a:off x="3017880" y="7066080"/>
              <a:ext cx="0" cy="1886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cxnSp>
        <p:nvCxnSpPr>
          <p:cNvPr id="113" name="直線矢印コネクタ 113"/>
          <p:cNvCxnSpPr/>
          <p:nvPr/>
        </p:nvCxnSpPr>
        <p:spPr>
          <a:xfrm>
            <a:off x="2361960" y="2944440"/>
            <a:ext cx="1080" cy="28332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lg"/>
          </a:ln>
        </p:spPr>
      </p:cxnSp>
      <p:sp>
        <p:nvSpPr>
          <p:cNvPr id="114" name="TextBox 223"/>
          <p:cNvSpPr/>
          <p:nvPr/>
        </p:nvSpPr>
        <p:spPr>
          <a:xfrm>
            <a:off x="2158920" y="2881440"/>
            <a:ext cx="4557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800" spc="-1" strike="noStrike">
                <a:solidFill>
                  <a:srgbClr val="ff0000"/>
                </a:solidFill>
                <a:latin typeface="Arial"/>
                <a:ea typeface="Arial"/>
              </a:rPr>
              <a:t>X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15" name="Group 15"/>
          <p:cNvGrpSpPr/>
          <p:nvPr/>
        </p:nvGrpSpPr>
        <p:grpSpPr>
          <a:xfrm>
            <a:off x="3198960" y="3876840"/>
            <a:ext cx="276120" cy="190080"/>
            <a:chOff x="3198960" y="3876840"/>
            <a:chExt cx="276120" cy="190080"/>
          </a:xfrm>
        </p:grpSpPr>
        <p:sp>
          <p:nvSpPr>
            <p:cNvPr id="116" name="Straight Connector 95"/>
            <p:cNvSpPr/>
            <p:nvPr/>
          </p:nvSpPr>
          <p:spPr>
            <a:xfrm flipV="1">
              <a:off x="3208320" y="3877920"/>
              <a:ext cx="0" cy="1890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Straight Connector 96"/>
            <p:cNvSpPr/>
            <p:nvPr/>
          </p:nvSpPr>
          <p:spPr>
            <a:xfrm>
              <a:off x="3198960" y="3876840"/>
              <a:ext cx="276120" cy="0"/>
            </a:xfrm>
            <a:prstGeom prst="line">
              <a:avLst/>
            </a:prstGeom>
            <a:ln w="414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118" name="テキスト ボックス 123" descr=""/>
          <p:cNvPicPr/>
          <p:nvPr/>
        </p:nvPicPr>
        <p:blipFill>
          <a:blip r:embed="rId8"/>
          <a:stretch/>
        </p:blipFill>
        <p:spPr>
          <a:xfrm>
            <a:off x="3780000" y="3621240"/>
            <a:ext cx="1023840" cy="218880"/>
          </a:xfrm>
          <a:prstGeom prst="rect">
            <a:avLst/>
          </a:prstGeom>
          <a:ln w="0">
            <a:noFill/>
          </a:ln>
        </p:spPr>
      </p:pic>
      <p:pic>
        <p:nvPicPr>
          <p:cNvPr id="119" name="テキスト ボックス 123" descr=""/>
          <p:cNvPicPr/>
          <p:nvPr/>
        </p:nvPicPr>
        <p:blipFill>
          <a:blip r:embed="rId9"/>
          <a:stretch/>
        </p:blipFill>
        <p:spPr>
          <a:xfrm>
            <a:off x="3932280" y="3773520"/>
            <a:ext cx="1023840" cy="218880"/>
          </a:xfrm>
          <a:prstGeom prst="rect">
            <a:avLst/>
          </a:prstGeom>
          <a:ln w="0">
            <a:noFill/>
          </a:ln>
        </p:spPr>
      </p:pic>
      <p:pic>
        <p:nvPicPr>
          <p:cNvPr id="120" name="テキスト ボックス 123" descr=""/>
          <p:cNvPicPr/>
          <p:nvPr/>
        </p:nvPicPr>
        <p:blipFill>
          <a:blip r:embed="rId10"/>
          <a:stretch/>
        </p:blipFill>
        <p:spPr>
          <a:xfrm>
            <a:off x="4084560" y="3925800"/>
            <a:ext cx="1023840" cy="219240"/>
          </a:xfrm>
          <a:prstGeom prst="rect">
            <a:avLst/>
          </a:prstGeom>
          <a:ln w="0">
            <a:noFill/>
          </a:ln>
        </p:spPr>
      </p:pic>
      <p:sp>
        <p:nvSpPr>
          <p:cNvPr id="121" name="Right Arrow 101"/>
          <p:cNvSpPr/>
          <p:nvPr/>
        </p:nvSpPr>
        <p:spPr>
          <a:xfrm>
            <a:off x="3728880" y="6780240"/>
            <a:ext cx="532080" cy="230040"/>
          </a:xfrm>
          <a:prstGeom prst="rightArrow">
            <a:avLst>
              <a:gd name="adj1" fmla="val 50000"/>
              <a:gd name="adj2" fmla="val 50061"/>
            </a:avLst>
          </a:prstGeom>
          <a:solidFill>
            <a:srgbClr val="ffffff"/>
          </a:solidFill>
          <a:ln w="255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22" name="直線矢印コネクタ 113"/>
          <p:cNvCxnSpPr/>
          <p:nvPr/>
        </p:nvCxnSpPr>
        <p:spPr>
          <a:xfrm flipH="1">
            <a:off x="2247120" y="6710040"/>
            <a:ext cx="345240" cy="329040"/>
          </a:xfrm>
          <a:prstGeom prst="straightConnector1">
            <a:avLst/>
          </a:prstGeom>
          <a:ln w="12600">
            <a:solidFill>
              <a:srgbClr val="953735"/>
            </a:solidFill>
            <a:prstDash val="dash"/>
            <a:miter/>
            <a:tailEnd len="med" type="triangle" w="med"/>
          </a:ln>
        </p:spPr>
      </p:cxnSp>
      <p:sp>
        <p:nvSpPr>
          <p:cNvPr id="123" name="TextBox 64"/>
          <p:cNvSpPr/>
          <p:nvPr/>
        </p:nvSpPr>
        <p:spPr>
          <a:xfrm>
            <a:off x="4961880" y="9609120"/>
            <a:ext cx="187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 S1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16T23:48:49Z</dcterms:created>
  <dc:creator>Jade Gong</dc:creator>
  <dc:description/>
  <dc:language>en-US</dc:language>
  <cp:lastModifiedBy>Eric Lam</cp:lastModifiedBy>
  <cp:lastPrinted>2014-09-26T09:57:40Z</cp:lastPrinted>
  <dcterms:modified xsi:type="dcterms:W3CDTF">2014-10-01T11:07:46Z</dcterms:modified>
  <cp:revision>591</cp:revision>
  <dc:subject/>
  <dc:title>PowerPoint Presentation</dc:title>
</cp:coreProperties>
</file>